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453" autoAdjust="0"/>
    <p:restoredTop sz="94660"/>
  </p:normalViewPr>
  <p:slideViewPr>
    <p:cSldViewPr snapToGrid="0">
      <p:cViewPr varScale="1">
        <p:scale>
          <a:sx n="136" d="100"/>
          <a:sy n="136" d="100"/>
        </p:scale>
        <p:origin x="-376" y="-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51554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1957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19500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01575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44651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886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8926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76236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87664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50261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22947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A7663-06A7-47C5-ADFE-8442F977A525}" type="datetimeFigureOut">
              <a:rPr lang="en-US" smtClean="0"/>
              <a:pPr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4E1E0D-EB5E-4973-9842-BDEDD3D9FBE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79092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61114" y="461486"/>
            <a:ext cx="306977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Genome resequencing data for 15 birds from four breed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561114" y="1476968"/>
            <a:ext cx="306977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Call SNPs: &gt;17.5m variants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561114" y="2215451"/>
            <a:ext cx="306977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lter SNPs: &gt;9.4m variants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318655" y="2951606"/>
            <a:ext cx="306977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SNPRelate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→ random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orest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318655" y="3687761"/>
            <a:ext cx="306977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NPs associated with NAA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47112" y="2951606"/>
            <a:ext cx="306977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elective sweep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847112" y="3687761"/>
            <a:ext cx="306977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Genomic regions associated with NAA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4040" y="6335486"/>
            <a:ext cx="118491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1 Fig. Flowchart of two methods used to identify candidate genes associated with North American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Araucana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(NAAs)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34040" y="2951606"/>
            <a:ext cx="2084615" cy="3680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Method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34040" y="3689015"/>
            <a:ext cx="2084615" cy="3680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Result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34040" y="1476968"/>
            <a:ext cx="2084615" cy="3680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reprocessing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318655" y="4423916"/>
            <a:ext cx="306977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22 SNPs: 26 candidate gene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847112" y="4700915"/>
            <a:ext cx="306977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12 candidate gene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Down Arrow 16"/>
          <p:cNvSpPr/>
          <p:nvPr/>
        </p:nvSpPr>
        <p:spPr>
          <a:xfrm>
            <a:off x="5938345" y="1198179"/>
            <a:ext cx="283779" cy="18918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Down Arrow 17"/>
          <p:cNvSpPr/>
          <p:nvPr/>
        </p:nvSpPr>
        <p:spPr>
          <a:xfrm>
            <a:off x="5938345" y="1932790"/>
            <a:ext cx="283779" cy="18918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Down Arrow 18"/>
          <p:cNvSpPr/>
          <p:nvPr/>
        </p:nvSpPr>
        <p:spPr>
          <a:xfrm>
            <a:off x="3711651" y="3401843"/>
            <a:ext cx="283779" cy="18918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Down Arrow 19"/>
          <p:cNvSpPr/>
          <p:nvPr/>
        </p:nvSpPr>
        <p:spPr>
          <a:xfrm>
            <a:off x="3659099" y="4153824"/>
            <a:ext cx="283779" cy="18918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Down Arrow 20"/>
          <p:cNvSpPr/>
          <p:nvPr/>
        </p:nvSpPr>
        <p:spPr>
          <a:xfrm>
            <a:off x="8240108" y="3435676"/>
            <a:ext cx="283779" cy="18918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Down Arrow 21"/>
          <p:cNvSpPr/>
          <p:nvPr/>
        </p:nvSpPr>
        <p:spPr>
          <a:xfrm>
            <a:off x="8240107" y="4419395"/>
            <a:ext cx="283779" cy="18918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Down Arrow 22"/>
          <p:cNvSpPr/>
          <p:nvPr/>
        </p:nvSpPr>
        <p:spPr>
          <a:xfrm rot="2835645">
            <a:off x="5412308" y="2700729"/>
            <a:ext cx="283779" cy="18918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Down Arrow 23"/>
          <p:cNvSpPr/>
          <p:nvPr/>
        </p:nvSpPr>
        <p:spPr>
          <a:xfrm rot="18883930">
            <a:off x="6538162" y="2673601"/>
            <a:ext cx="283779" cy="189187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>
            <a:off x="234040" y="2768194"/>
            <a:ext cx="11849101" cy="27128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192469" y="3521027"/>
            <a:ext cx="11849101" cy="27128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609410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68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lemson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oksie</dc:creator>
  <cp:lastModifiedBy>Vijay</cp:lastModifiedBy>
  <cp:revision>5</cp:revision>
  <dcterms:created xsi:type="dcterms:W3CDTF">2019-08-14T05:39:11Z</dcterms:created>
  <dcterms:modified xsi:type="dcterms:W3CDTF">2019-08-15T02:46:37Z</dcterms:modified>
</cp:coreProperties>
</file>